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D214E-B1B8-40C8-9BDE-2204B05D99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FB6A8-F08E-4050-BF2C-A257D5B173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7857EB-E129-4CD6-BFB4-AE9C036FEF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E6EC6-D712-4096-ACDA-7133688170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0BCA6-845E-4268-80C8-DEA83599FD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BC3E0-FA6A-4EBB-936D-6BCC969F5C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BA49C0-C313-42BF-8110-B60D778E56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BB7387-45BD-4A71-A9ED-FF610FEBFE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44898-A1E9-4466-8C28-7C0E93AB71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F1497-2558-4884-87A6-32E913780D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9F85C0-8A81-4B7D-8943-497D4B4649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BAAB2B-A3C4-4A43-ADFA-81522762CC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BC8995-C484-43B3-ABD8-807B014C9F6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0"/>
          <a:ext cx="6858000" cy="15116040"/>
        </p:xfrm>
        <a:graphic>
          <a:graphicData uri="http://schemas.openxmlformats.org/drawingml/2006/table">
            <a:tbl>
              <a:tblPr/>
              <a:tblGrid>
                <a:gridCol w="1714680"/>
                <a:gridCol w="1714320"/>
                <a:gridCol w="1714680"/>
                <a:gridCol w="1714320"/>
              </a:tblGrid>
              <a:tr h="1039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. subtilis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as query spec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proteins with at least 50% sequence similarity to a quer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inser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dele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66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quifex aeolicus VF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3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6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4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nabaena variabilis ATCC 294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2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5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7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dellovibrio bacteriovorus HD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7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hlamydia trachomatis A/HAR- 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9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hlamydia trachomatis D/UW-3/C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7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halococcoides ethenogenes 1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7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inococcus radiodurans 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636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usobacterium nucleatum subsp. nucleatum ATCC 255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7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licobacter hepaticus ATCC 514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8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5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elicobacter pylori J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59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ycobacterium tuberculosis CDC15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7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ycobacterium tuberculosis H37R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6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9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isseria gonorrhoeae FA 10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7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isseria meningitidis MC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59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isseria meningitidis Z24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7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ckettsia prowazekii str. Madrid 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5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aphylococcus aureus C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6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79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phylococcus aureus subsp. aureus Mu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3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8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phylococcus aureus subsp. aureus MW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6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8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phylococcus aureus subsp. aureus NCTC 83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7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9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ermotoga maritima MSB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3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59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eponema denticola ATCC 354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"/>
          <p:cNvGraphicFramePr/>
          <p:nvPr/>
        </p:nvGraphicFramePr>
        <p:xfrm>
          <a:off x="0" y="-36360"/>
          <a:ext cx="6858000" cy="14063400"/>
        </p:xfrm>
        <a:graphic>
          <a:graphicData uri="http://schemas.openxmlformats.org/drawingml/2006/table">
            <a:tbl>
              <a:tblPr/>
              <a:tblGrid>
                <a:gridCol w="1714680"/>
                <a:gridCol w="1714320"/>
                <a:gridCol w="1714680"/>
                <a:gridCol w="1714320"/>
              </a:tblGrid>
              <a:tr h="8240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. coli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as query spec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proteins with at least 50% sequence similarity to a query prote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inser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dele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65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quifex aeolicus VF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4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nabaena variabilis ATCC 294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9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8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48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dellovibrio bacteriovorus HD1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1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hlamydia trachomatis A/HAR- 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1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hlamydia trachomatis D/UW-3/C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7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8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halococcoides ethenogenes 1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7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inococcus radiodurans R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240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usobacterium nucleatum subsp. nucleatum ATCC 255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1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licobacter hepaticus ATCC 514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elicobacter pylori J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8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8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ycobacterium tuberculosis CDC15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8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ycobacterium tuberculosis H37Rv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7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14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isseria gonorrhoeae FA 10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isseria meningitidis MC5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6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eisseria meningitidis Z24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18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ckettsia prowazekii str. Madrid 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aphylococcus aureus C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3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1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phylococcus aureus subsp. aureus Mu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1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phylococcus aureus subsp. aureus MW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3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41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phylococcus aureus subsp. aureus NCTC 83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4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79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ermotoga maritima MSB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3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66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eponema denticola ATCC 354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0" y="0"/>
          <a:ext cx="6858000" cy="9161640"/>
        </p:xfrm>
        <a:graphic>
          <a:graphicData uri="http://schemas.openxmlformats.org/drawingml/2006/table">
            <a:tbl>
              <a:tblPr/>
              <a:tblGrid>
                <a:gridCol w="1714680"/>
                <a:gridCol w="1714320"/>
                <a:gridCol w="1714680"/>
                <a:gridCol w="1714320"/>
              </a:tblGrid>
              <a:tr h="10839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. cerevisiae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as query speci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proteins with at least 50% sequence similarity to a query prote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inser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mber of dele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9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rabidopsis thalia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8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5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88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99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aenorhabditis elega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3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4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6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andida glabrata CBS 1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8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8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13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yptococcus neoformans var. neoformans JEC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7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7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2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40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ebaryomyces hansenii CBS7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4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0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6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Drosophila melanogast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24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27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6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18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tamoeba histolytica HM-1:IM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0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695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40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64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remothecium gossypi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6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2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8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7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omo sapie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50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48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43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5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Kluyveromyces lactis NRRL Y-11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0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3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74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us musculu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94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076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0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92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Oryza sativ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36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9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5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chizosaccharomyces pomb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4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2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15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251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rypanosoma cruz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49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5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0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Yarrowia lipolytica CLIB9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96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9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5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8T20:28:12Z</dcterms:created>
  <dc:creator>sichan</dc:creator>
  <dc:description/>
  <dc:language>en-US</dc:language>
  <cp:lastModifiedBy>sichan</cp:lastModifiedBy>
  <dcterms:modified xsi:type="dcterms:W3CDTF">2007-06-13T18:02:35Z</dcterms:modified>
  <cp:revision>3</cp:revision>
  <dc:subject/>
  <dc:title>Slide 1</dc:title>
</cp:coreProperties>
</file>